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2.jpeg" ContentType="image/jpe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907588"/>
  <p:notesSz cx="6796088" cy="992505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6959CA88-2D55-4885-903A-42495A79325A}"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342720" y="23112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9CDD5CC-915A-4EC6-8358-1BD17412E14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BE7FA579-B096-46D0-B770-BAB86118733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34272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242964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4516560" y="23112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34272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242964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4516560" y="5725800"/>
            <a:ext cx="1987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C70D2B2C-EBAD-437E-9CF3-E5AD6F6BF458}"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342720" y="2311200"/>
            <a:ext cx="6172200" cy="653724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ACDD022-8E95-4D39-8398-834A0F2EFB7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342720" y="2311200"/>
            <a:ext cx="617220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C8B4F70B-DFA6-400F-8E15-DDF7297E8326}"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3A37351F-F3EA-4387-9B89-6E5988BA658B}"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606F88B8-5A32-44AD-9232-CD1CDA3767DB}"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2720" y="396360"/>
            <a:ext cx="6172200" cy="76557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C9C6C1B-C7BE-48F8-A7A9-44F79FE83B9F}"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35053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3427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34649028-9FDE-4FC3-AD9D-B34F0901AF7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342720" y="2311200"/>
            <a:ext cx="3011760" cy="653724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3505320" y="57258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96E7FE7-2502-4497-BDC9-FB8571DB42C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3427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3505320" y="2311200"/>
            <a:ext cx="301176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342720" y="5725800"/>
            <a:ext cx="6172200" cy="31179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6CF5728-5700-4436-BEF9-04445025F3B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2720" y="396360"/>
            <a:ext cx="6172200" cy="165132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342720" y="2311200"/>
            <a:ext cx="6172200" cy="653724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342720" y="9019800"/>
            <a:ext cx="1600200" cy="68724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2343240" y="9019800"/>
            <a:ext cx="2171520" cy="68724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4914720" y="9019800"/>
            <a:ext cx="1600200" cy="68724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CCD04796-1417-4AF1-8514-906F12F88BC1}"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2.jpeg"/><Relationship Id="rId4"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549360" y="5173560"/>
            <a:ext cx="5759280" cy="1554120"/>
          </a:xfrm>
          <a:prstGeom prst="rect">
            <a:avLst/>
          </a:prstGeom>
          <a:noFill/>
          <a:ln w="0">
            <a:noFill/>
          </a:ln>
        </p:spPr>
        <p:style>
          <a:lnRef idx="0"/>
          <a:fillRef idx="0"/>
          <a:effectRef idx="0"/>
          <a:fontRef idx="minor"/>
        </p:style>
        <p:txBody>
          <a:bodyPr lIns="90000" rIns="90000" tIns="46800" bIns="46800" anchor="t">
            <a:spAutoFit/>
          </a:bodyPr>
          <a:p>
            <a:pPr algn="just">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Times New Roman"/>
              </a:rPr>
              <a:t>Additional file 2 - Silver staining of protein extract and tryptic digest run on SDS-PAGE. </a:t>
            </a:r>
            <a:r>
              <a:rPr b="0" lang="en-US" sz="1200" spc="-1" strike="noStrike">
                <a:solidFill>
                  <a:srgbClr val="000000"/>
                </a:solidFill>
                <a:latin typeface="Times New Roman"/>
              </a:rPr>
              <a:t>The figure shows the similar amount of proteins run for three biological replicates. Control protein extracts, labeled with iTRAQ 113, 115 and 119 were loaded onto lanes 1, 5 and 9, respectively, while BaP-exposed protein extracts, labeled with iTRAQ 114, 116 and 121 were loaded onto lanes 3, 7 and 11, respectively. Tryptic digested products were loaded on the neighboring lanes to the right of the corresponding protein extracts, and show the protein digestion was complete under the used conditions. Molecular weight markers were loaded onto lanes labeled with M.</a:t>
            </a:r>
            <a:endParaRPr b="0" lang="en-US" sz="1200" spc="-1" strike="noStrike">
              <a:solidFill>
                <a:srgbClr val="000000"/>
              </a:solidFill>
              <a:latin typeface="Arial"/>
            </a:endParaRPr>
          </a:p>
        </p:txBody>
      </p:sp>
      <p:grpSp>
        <p:nvGrpSpPr>
          <p:cNvPr id="42" name=""/>
          <p:cNvGrpSpPr/>
          <p:nvPr/>
        </p:nvGrpSpPr>
        <p:grpSpPr>
          <a:xfrm>
            <a:off x="1616040" y="2036880"/>
            <a:ext cx="3625560" cy="2484360"/>
            <a:chOff x="1616040" y="2036880"/>
            <a:chExt cx="3625560" cy="2484360"/>
          </a:xfrm>
        </p:grpSpPr>
        <p:pic>
          <p:nvPicPr>
            <p:cNvPr id="43" name="" descr=""/>
            <p:cNvPicPr/>
            <p:nvPr/>
          </p:nvPicPr>
          <p:blipFill>
            <a:blip r:embed="rId1"/>
            <a:srcRect l="1043" t="9638" r="0" b="0"/>
            <a:stretch/>
          </p:blipFill>
          <p:spPr>
            <a:xfrm>
              <a:off x="1616040" y="2287440"/>
              <a:ext cx="2257200" cy="2173320"/>
            </a:xfrm>
            <a:prstGeom prst="rect">
              <a:avLst/>
            </a:prstGeom>
            <a:ln w="0">
              <a:noFill/>
            </a:ln>
          </p:spPr>
        </p:pic>
        <p:pic>
          <p:nvPicPr>
            <p:cNvPr id="44" name="" descr=""/>
            <p:cNvPicPr/>
            <p:nvPr/>
          </p:nvPicPr>
          <p:blipFill>
            <a:blip r:embed="rId2"/>
            <a:srcRect l="-1278" t="5858" r="88064" b="-2824"/>
            <a:stretch/>
          </p:blipFill>
          <p:spPr>
            <a:xfrm>
              <a:off x="3848040" y="2287440"/>
              <a:ext cx="295200" cy="2233800"/>
            </a:xfrm>
            <a:prstGeom prst="rect">
              <a:avLst/>
            </a:prstGeom>
            <a:ln w="0">
              <a:noFill/>
            </a:ln>
          </p:spPr>
        </p:pic>
        <p:sp>
          <p:nvSpPr>
            <p:cNvPr id="45" name=""/>
            <p:cNvSpPr/>
            <p:nvPr/>
          </p:nvSpPr>
          <p:spPr>
            <a:xfrm>
              <a:off x="1616040" y="2036880"/>
              <a:ext cx="223200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M  1  2   3   4   5   6   7   8</a:t>
              </a:r>
              <a:endParaRPr b="0" lang="en-US" sz="1400" spc="-1" strike="noStrike">
                <a:solidFill>
                  <a:srgbClr val="000000"/>
                </a:solidFill>
                <a:latin typeface="Arial"/>
              </a:endParaRPr>
            </a:p>
          </p:txBody>
        </p:sp>
        <p:pic>
          <p:nvPicPr>
            <p:cNvPr id="46" name="" descr=""/>
            <p:cNvPicPr/>
            <p:nvPr/>
          </p:nvPicPr>
          <p:blipFill>
            <a:blip r:embed="rId3"/>
            <a:srcRect l="53377" t="6203" r="0" b="0"/>
            <a:stretch/>
          </p:blipFill>
          <p:spPr>
            <a:xfrm>
              <a:off x="4135320" y="2287440"/>
              <a:ext cx="1041480" cy="2160720"/>
            </a:xfrm>
            <a:prstGeom prst="rect">
              <a:avLst/>
            </a:prstGeom>
            <a:ln w="0">
              <a:noFill/>
            </a:ln>
          </p:spPr>
        </p:pic>
        <p:sp>
          <p:nvSpPr>
            <p:cNvPr id="47" name=""/>
            <p:cNvSpPr/>
            <p:nvPr/>
          </p:nvSpPr>
          <p:spPr>
            <a:xfrm>
              <a:off x="3875040" y="2036880"/>
              <a:ext cx="1366560" cy="307080"/>
            </a:xfrm>
            <a:prstGeom prst="rect">
              <a:avLst/>
            </a:prstGeom>
            <a:noFill/>
            <a:ln w="0">
              <a:noFill/>
            </a:ln>
          </p:spPr>
          <p:style>
            <a:lnRef idx="0"/>
            <a:fillRef idx="0"/>
            <a:effectRef idx="0"/>
            <a:fontRef idx="minor"/>
          </p:style>
          <p:txBody>
            <a:bodyPr lIns="90000" rIns="90000" tIns="46800" bIns="46800" anchor="t">
              <a:spAutoFit/>
            </a:bodyPr>
            <a:p>
              <a:pP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M  9  10 11 12</a:t>
              </a:r>
              <a:endParaRPr b="0" lang="en-US" sz="1400" spc="-1" strike="noStrike">
                <a:solidFill>
                  <a:srgbClr val="000000"/>
                </a:solidFill>
                <a:latin typeface="Arial"/>
              </a:endParaRPr>
            </a:p>
          </p:txBody>
        </p:sp>
      </p:gr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1839</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04-26T13:18:47Z</dcterms:created>
  <dc:creator>Raquel Negrão Carvalho</dc:creator>
  <dc:description/>
  <dc:language>en-US</dc:language>
  <cp:lastModifiedBy>Raquel Negrão Carvalho</cp:lastModifiedBy>
  <dcterms:modified xsi:type="dcterms:W3CDTF">2011-02-08T11:51:18Z</dcterms:modified>
  <cp:revision>21</cp:revision>
  <dc:subject/>
  <dc:title>Slide 1</dc:title>
</cp:coreProperties>
</file>